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B4FD7F-620A-1FA0-C177-113F270BCF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BC1991B-EB7A-B2C7-C549-BE2ABED72D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68FA9B-7ABE-CBFF-6E21-628848D24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3A7C-A903-462B-AFCD-D3AD7B270470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0974F43-D064-AAA4-73FE-9C4DFED6C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810F54E-8CBA-1648-1668-787C17B9E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ADB8F-8F73-457A-840F-F0E599F643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935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79D904-A647-F097-0DB8-F52B32DE4B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83811C5-35B0-489F-9549-3FFDA89AC4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D0A0B3-1DD9-150C-E185-2B98ECFE7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3A7C-A903-462B-AFCD-D3AD7B270470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614D525-ED69-FC04-020E-5B326040E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B92BEE8-3013-24A3-ECA7-5321DE966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ADB8F-8F73-457A-840F-F0E599F643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6285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5B1EA75-7134-E0EE-401E-B33B87B81F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65D3AB8-4119-29FE-296C-27325517B8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5EAC9EB-FDBF-EAE3-17F7-1022384B5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3A7C-A903-462B-AFCD-D3AD7B270470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BA3B47-521E-A1E2-4C62-BC8A3610E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E2E0CF9-31B9-83F8-E9A9-69696506C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ADB8F-8F73-457A-840F-F0E599F643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0957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040D82-E89D-D38A-E8F6-79B2EB727E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1F7707-86E3-8530-3F64-C2FE6B83BC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4BC5D7-722F-0A6B-04D1-FCB43E8D0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3A7C-A903-462B-AFCD-D3AD7B270470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CFA84D5-0D62-D330-0878-45030D1264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46F918-47AD-55A4-9B66-BE502E8EC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ADB8F-8F73-457A-840F-F0E599F643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8962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8EE620-D7B5-F069-C4A5-3E3587FAE9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3521469-0C12-3B30-16C5-D509F9C1BD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537F635-B3CA-B297-8A37-3975539C36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3A7C-A903-462B-AFCD-D3AD7B270470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FF3DDF-4519-A714-B260-AFBF4C10E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346AA8-92F0-6D0C-BB5A-642225B56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ADB8F-8F73-457A-840F-F0E599F643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6975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8C1E8A-6D06-D80C-BBCE-270108C206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A349430-32EC-C1E4-C810-05D1212EBD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8507D1D-C863-7472-3475-23E0B747C3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82F2AF2-63F5-A774-176C-DAAA347FA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3A7C-A903-462B-AFCD-D3AD7B270470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75D7CDE-91BE-AFC6-BE6C-F847ABD9D0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C09C6FE-B594-F98D-BC3B-985F5E20E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ADB8F-8F73-457A-840F-F0E599F643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7882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D411F3-1E00-F019-E8FA-C6D389B9EA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B93DDF1-D3B3-046E-0B42-34D62BB415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79DA377-D5D4-D48C-D3DC-069CDDC4AE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28E0CCF-65E4-A39F-FB95-24244B6B1B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E6BF9AA-C596-3193-7B6F-2D68D14FFE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260309A-7454-45AA-2DA7-9C644EA9F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3A7C-A903-462B-AFCD-D3AD7B270470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E4B7E54-5345-E360-1CD1-E5B3F9214C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DFAE95C-22BF-F647-66A4-3C959C8C41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ADB8F-8F73-457A-840F-F0E599F643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8684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9DBA21-248A-F64B-5684-ABE1E9D9EA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F6A6B3A-0249-0DE6-6C02-A65A738AF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3A7C-A903-462B-AFCD-D3AD7B270470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B29CF5D-41B4-3745-7996-70080C0FC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9740998-C516-0359-22A9-076982522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ADB8F-8F73-457A-840F-F0E599F643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7300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4BCADAB-2FB5-CAA5-1DE6-FE78C25FD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3A7C-A903-462B-AFCD-D3AD7B270470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83C69E0-A070-BBAE-AD27-79D1936FB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0AC8284-C2DB-B22C-ED73-7F89A5EFA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ADB8F-8F73-457A-840F-F0E599F643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9866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1CD6F7-F416-7860-11E0-00387415F5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5A82811-9A99-D36D-D85C-876C3CCC47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ABCA1E9-FBA0-6904-4A5B-F352CB9ABA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DE64C8F-4774-A7D7-C13E-791B09FEB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3A7C-A903-462B-AFCD-D3AD7B270470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D568B7D-0557-036C-95A9-4578321902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B6BA17C-DA2C-5DBE-0B71-A80B5DEB9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ADB8F-8F73-457A-840F-F0E599F643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0977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DEC3BC-C40B-A323-6F7C-8E418BD7C5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DA43CDB-AAD8-75F3-C3D9-3C8B0FC039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2C30AF3-CE72-252C-3DA9-1708E7A195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2B435DA-9AC2-76F8-EB78-14CD1A2DB7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3A7C-A903-462B-AFCD-D3AD7B270470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6C3D18E-2B3A-7F37-97F6-E26522BA0F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B3A66CA-56AE-BEFD-9282-47B48B2A6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ADB8F-8F73-457A-840F-F0E599F643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5843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B9DE3F8-8C06-23DA-C756-79463FC6E6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515EB0E-4A82-81D4-2C72-BE26B5455B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402FB5-4C81-AF58-BA53-3538E2A261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6C3A7C-A903-462B-AFCD-D3AD7B270470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54CD02-C81A-EB10-E42E-3E0773BEB8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B27E8F-0D00-0D11-C25D-A82821A9DB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8ADB8F-8F73-457A-840F-F0E599F643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2924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9B26D0F-9EC1-CF65-73F6-2312F47462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10819" y="1603637"/>
            <a:ext cx="1476375" cy="299085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9EC87CF-3778-71CE-F685-40764497A306}"/>
              </a:ext>
            </a:extLst>
          </p:cNvPr>
          <p:cNvSpPr txBox="1"/>
          <p:nvPr/>
        </p:nvSpPr>
        <p:spPr>
          <a:xfrm>
            <a:off x="5137608" y="5995447"/>
            <a:ext cx="2592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 Fig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4C481DA-08F9-A3FD-8A4D-FCC1FCD73000}"/>
              </a:ext>
            </a:extLst>
          </p:cNvPr>
          <p:cNvSpPr txBox="1"/>
          <p:nvPr/>
        </p:nvSpPr>
        <p:spPr>
          <a:xfrm>
            <a:off x="766960" y="1138102"/>
            <a:ext cx="480767" cy="377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EE11484-2A21-82A6-8535-4D535FBDEBE8}"/>
              </a:ext>
            </a:extLst>
          </p:cNvPr>
          <p:cNvSpPr txBox="1"/>
          <p:nvPr/>
        </p:nvSpPr>
        <p:spPr>
          <a:xfrm>
            <a:off x="7582538" y="1333893"/>
            <a:ext cx="15284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kumimoji="1"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a-N     Ca-T       M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C498598-9DAA-6513-33FD-5B0119675FA3}"/>
              </a:ext>
            </a:extLst>
          </p:cNvPr>
          <p:cNvSpPr txBox="1"/>
          <p:nvPr/>
        </p:nvSpPr>
        <p:spPr>
          <a:xfrm>
            <a:off x="9030632" y="1604717"/>
            <a:ext cx="68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16</a:t>
            </a:r>
            <a:endParaRPr lang="zh-CN" altLang="en-US" sz="120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B3E695E-0133-13D0-690F-42CDA8DFDB35}"/>
              </a:ext>
            </a:extLst>
          </p:cNvPr>
          <p:cNvSpPr txBox="1"/>
          <p:nvPr/>
        </p:nvSpPr>
        <p:spPr>
          <a:xfrm>
            <a:off x="9044736" y="1881716"/>
            <a:ext cx="796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66.2</a:t>
            </a:r>
            <a:endParaRPr lang="zh-CN" altLang="en-US" sz="12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95F9CCF-CDAE-8685-D524-608D9E06725D}"/>
              </a:ext>
            </a:extLst>
          </p:cNvPr>
          <p:cNvSpPr txBox="1"/>
          <p:nvPr/>
        </p:nvSpPr>
        <p:spPr>
          <a:xfrm>
            <a:off x="9049486" y="2222374"/>
            <a:ext cx="68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45</a:t>
            </a:r>
            <a:endParaRPr lang="zh-CN" altLang="en-US" sz="12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03FBA81-C9CD-7AC9-E0F9-4102A77145E5}"/>
              </a:ext>
            </a:extLst>
          </p:cNvPr>
          <p:cNvSpPr txBox="1"/>
          <p:nvPr/>
        </p:nvSpPr>
        <p:spPr>
          <a:xfrm>
            <a:off x="9058913" y="2581886"/>
            <a:ext cx="68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5</a:t>
            </a:r>
            <a:endParaRPr lang="zh-CN" altLang="en-US" sz="12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4B0866C-5015-85E1-33CB-10AB263CEBE6}"/>
              </a:ext>
            </a:extLst>
          </p:cNvPr>
          <p:cNvSpPr txBox="1"/>
          <p:nvPr/>
        </p:nvSpPr>
        <p:spPr>
          <a:xfrm>
            <a:off x="9049486" y="3109028"/>
            <a:ext cx="68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</a:t>
            </a:r>
            <a:endParaRPr lang="zh-CN" altLang="en-US" sz="12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5FB438F-84D9-9DEA-EFF1-8C1F74BC5235}"/>
              </a:ext>
            </a:extLst>
          </p:cNvPr>
          <p:cNvSpPr txBox="1"/>
          <p:nvPr/>
        </p:nvSpPr>
        <p:spPr>
          <a:xfrm>
            <a:off x="9049486" y="3708544"/>
            <a:ext cx="796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8.4</a:t>
            </a:r>
            <a:endParaRPr lang="zh-CN" altLang="en-US" sz="12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3A0291C-8ED2-663F-A87D-1D7A1DA5DD16}"/>
              </a:ext>
            </a:extLst>
          </p:cNvPr>
          <p:cNvSpPr txBox="1"/>
          <p:nvPr/>
        </p:nvSpPr>
        <p:spPr>
          <a:xfrm>
            <a:off x="9049486" y="4016922"/>
            <a:ext cx="796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4.4</a:t>
            </a:r>
            <a:endParaRPr lang="zh-CN" altLang="en-US" sz="12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7FCD6AF-70D7-6420-055F-2C157C27652F}"/>
              </a:ext>
            </a:extLst>
          </p:cNvPr>
          <p:cNvSpPr txBox="1"/>
          <p:nvPr/>
        </p:nvSpPr>
        <p:spPr>
          <a:xfrm>
            <a:off x="9058913" y="1326638"/>
            <a:ext cx="79684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98E32326-9251-8FF3-53EC-24CFE279AE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2724" y="2689748"/>
            <a:ext cx="3795970" cy="1855932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BFA89E40-F489-AB67-537F-7D123750987A}"/>
              </a:ext>
            </a:extLst>
          </p:cNvPr>
          <p:cNvSpPr txBox="1"/>
          <p:nvPr/>
        </p:nvSpPr>
        <p:spPr>
          <a:xfrm>
            <a:off x="4128818" y="4504939"/>
            <a:ext cx="174408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concentration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ug/</a:t>
            </a:r>
            <a:r>
              <a:rPr lang="en-US" altLang="zh-CN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l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512795F-8188-413A-58FF-60887DCC2E1F}"/>
              </a:ext>
            </a:extLst>
          </p:cNvPr>
          <p:cNvSpPr txBox="1"/>
          <p:nvPr/>
        </p:nvSpPr>
        <p:spPr>
          <a:xfrm rot="10800000">
            <a:off x="1705823" y="2581886"/>
            <a:ext cx="346249" cy="72967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D value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79546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32751B7F-5B1B-B52E-4E26-91A64677E8A8}"/>
              </a:ext>
            </a:extLst>
          </p:cNvPr>
          <p:cNvSpPr txBox="1"/>
          <p:nvPr/>
        </p:nvSpPr>
        <p:spPr>
          <a:xfrm>
            <a:off x="455875" y="1122296"/>
            <a:ext cx="480767" cy="377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3C5D49D-4169-A21D-A300-6BC1CE6B1CF5}"/>
              </a:ext>
            </a:extLst>
          </p:cNvPr>
          <p:cNvSpPr txBox="1"/>
          <p:nvPr/>
        </p:nvSpPr>
        <p:spPr>
          <a:xfrm>
            <a:off x="2355636" y="4802708"/>
            <a:ext cx="387233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Global Papillary Thyroid Cancers</a:t>
            </a:r>
            <a:endParaRPr lang="zh-CN" altLang="en-US" sz="1400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64B38789-E167-A71D-1D3D-0A65E037D7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88160" y="1904719"/>
            <a:ext cx="4232153" cy="2819104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B7349C6C-2173-24CE-06BA-DAEB112644BA}"/>
              </a:ext>
            </a:extLst>
          </p:cNvPr>
          <p:cNvSpPr txBox="1"/>
          <p:nvPr/>
        </p:nvSpPr>
        <p:spPr>
          <a:xfrm>
            <a:off x="6827363" y="4797908"/>
            <a:ext cx="399460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ea typeface="宋体" panose="02010600030101010101" pitchFamily="2" charset="-122"/>
              </a:rPr>
              <a:t>Acetylated Proteins of Papillary Thyroid Cancers</a:t>
            </a:r>
            <a:endParaRPr lang="zh-CN" altLang="en-US" sz="14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C3A0E05E-1E86-869D-E4B3-93320206F6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4483" y="1963709"/>
            <a:ext cx="4393491" cy="27601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370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34</Words>
  <Application>Microsoft Office PowerPoint</Application>
  <PresentationFormat>宽屏</PresentationFormat>
  <Paragraphs>1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石琦</dc:creator>
  <cp:lastModifiedBy>石琦</cp:lastModifiedBy>
  <cp:revision>5</cp:revision>
  <dcterms:created xsi:type="dcterms:W3CDTF">2023-03-16T05:18:33Z</dcterms:created>
  <dcterms:modified xsi:type="dcterms:W3CDTF">2023-03-16T06:59:16Z</dcterms:modified>
</cp:coreProperties>
</file>